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F2987"/>
    <a:srgbClr val="934BC9"/>
    <a:srgbClr val="2D6BB5"/>
    <a:srgbClr val="D01271"/>
    <a:srgbClr val="3276C8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2" d="100"/>
          <a:sy n="62" d="100"/>
        </p:scale>
        <p:origin x="-18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FA518D-DD56-4AE3-B54F-E78A7E3499E3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019C0E-B6CC-4CEC-9A04-8A7AB5A4712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72441" y="592186"/>
            <a:ext cx="5562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able 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he ratios of relative transcripts abundance of the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CESA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 in root (R), leaf (L) and stem (S) tissue.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609600" y="1371600"/>
          <a:ext cx="2844800" cy="2313432"/>
        </p:xfrm>
        <a:graphic>
          <a:graphicData uri="http://schemas.openxmlformats.org/drawingml/2006/table">
            <a:tbl>
              <a:tblPr/>
              <a:tblGrid>
                <a:gridCol w="1016000"/>
                <a:gridCol w="609600"/>
                <a:gridCol w="609600"/>
                <a:gridCol w="609600"/>
              </a:tblGrid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ene </a:t>
                      </a:r>
                      <a:endParaRPr lang="en-U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/L </a:t>
                      </a:r>
                      <a:endParaRPr lang="en-U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/L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/R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1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8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.6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2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2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7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8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1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3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8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2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1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4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6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2.5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8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5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7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4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8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6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.5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.9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3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7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6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1.0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3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8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3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.6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7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9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4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4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3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dCESA10 </a:t>
                      </a:r>
                      <a:endParaRPr lang="en-U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9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9</a:t>
                      </a:r>
                      <a:endParaRPr lang="en-US" sz="1100" i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0</a:t>
                      </a:r>
                      <a:endParaRPr lang="en-US" sz="1100" i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</TotalTime>
  <Words>72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ubudu</dc:creator>
  <cp:lastModifiedBy>Pubudu Handakumbura</cp:lastModifiedBy>
  <cp:revision>137</cp:revision>
  <dcterms:created xsi:type="dcterms:W3CDTF">2006-08-16T00:00:00Z</dcterms:created>
  <dcterms:modified xsi:type="dcterms:W3CDTF">2013-07-16T22:12:53Z</dcterms:modified>
</cp:coreProperties>
</file>